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0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49ED2"/>
    <a:srgbClr val="1A479E"/>
    <a:srgbClr val="FC8D59"/>
    <a:srgbClr val="91BFDB"/>
    <a:srgbClr val="F8766D"/>
    <a:srgbClr val="5ADDFE"/>
    <a:srgbClr val="56C5D4"/>
    <a:srgbClr val="EEEE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711" autoAdjust="0"/>
  </p:normalViewPr>
  <p:slideViewPr>
    <p:cSldViewPr snapToGrid="0">
      <p:cViewPr>
        <p:scale>
          <a:sx n="140" d="100"/>
          <a:sy n="140" d="100"/>
        </p:scale>
        <p:origin x="1782" y="-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F1877C-87EF-46DC-99F9-8F6F7C731258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210EEB-8E35-448A-970E-9E5DD1DA72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581120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9496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8066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7740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4041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0322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7746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3454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0752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4720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3566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0796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AF583-4495-4468-A495-623E8A37E162}" type="datetimeFigureOut">
              <a:rPr lang="es-ES" smtClean="0"/>
              <a:t>19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195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0B4B77C-DE0F-F1D1-3785-9DFBFA47990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n 11">
            <a:extLst>
              <a:ext uri="{FF2B5EF4-FFF2-40B4-BE49-F238E27FC236}">
                <a16:creationId xmlns:a16="http://schemas.microsoft.com/office/drawing/2014/main" id="{66117EE8-7833-67D5-47A0-661C9C2CF0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2610673" y="2572534"/>
            <a:ext cx="7905534" cy="5533874"/>
          </a:xfrm>
          <a:prstGeom prst="rect">
            <a:avLst/>
          </a:prstGeom>
        </p:spPr>
      </p:pic>
      <p:grpSp>
        <p:nvGrpSpPr>
          <p:cNvPr id="3" name="Grupo 2">
            <a:extLst>
              <a:ext uri="{FF2B5EF4-FFF2-40B4-BE49-F238E27FC236}">
                <a16:creationId xmlns:a16="http://schemas.microsoft.com/office/drawing/2014/main" id="{156A005B-5D11-1192-9B86-557FA95D3CA6}"/>
              </a:ext>
            </a:extLst>
          </p:cNvPr>
          <p:cNvGrpSpPr/>
          <p:nvPr/>
        </p:nvGrpSpPr>
        <p:grpSpPr>
          <a:xfrm rot="10800000">
            <a:off x="166808" y="205997"/>
            <a:ext cx="5157251" cy="9494006"/>
            <a:chOff x="1561268" y="157855"/>
            <a:chExt cx="5157251" cy="9494006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EF7ADB4D-ED2A-0406-462B-B1B6D0DDF8E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5400000">
              <a:off x="299599" y="2094389"/>
              <a:ext cx="6313166" cy="2937605"/>
            </a:xfrm>
            <a:prstGeom prst="rect">
              <a:avLst/>
            </a:prstGeom>
          </p:spPr>
        </p:pic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B3CE52FA-3E22-8F16-20ED-F670E846DEA4}"/>
                </a:ext>
              </a:extLst>
            </p:cNvPr>
            <p:cNvSpPr txBox="1"/>
            <p:nvPr/>
          </p:nvSpPr>
          <p:spPr>
            <a:xfrm rot="5400000">
              <a:off x="4819829" y="7753170"/>
              <a:ext cx="35511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. 1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57704089-25AE-307B-BEDD-74AC33542248}"/>
                </a:ext>
              </a:extLst>
            </p:cNvPr>
            <p:cNvSpPr txBox="1"/>
            <p:nvPr/>
          </p:nvSpPr>
          <p:spPr>
            <a:xfrm rot="5400000">
              <a:off x="6196603" y="187330"/>
              <a:ext cx="3051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C873E397-9A9F-AD69-8D0B-CD541D423739}"/>
                </a:ext>
              </a:extLst>
            </p:cNvPr>
            <p:cNvSpPr txBox="1"/>
            <p:nvPr/>
          </p:nvSpPr>
          <p:spPr>
            <a:xfrm rot="5400000">
              <a:off x="4479167" y="187329"/>
              <a:ext cx="3051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5C9CD28F-8BF9-E42D-AF3C-0766597DCBB6}"/>
                </a:ext>
              </a:extLst>
            </p:cNvPr>
            <p:cNvSpPr txBox="1"/>
            <p:nvPr/>
          </p:nvSpPr>
          <p:spPr>
            <a:xfrm rot="5400000">
              <a:off x="4479167" y="6823679"/>
              <a:ext cx="3051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2" name="Imagen 1">
              <a:extLst>
                <a:ext uri="{FF2B5EF4-FFF2-40B4-BE49-F238E27FC236}">
                  <a16:creationId xmlns:a16="http://schemas.microsoft.com/office/drawing/2014/main" id="{701299A4-DF0E-8865-BEAF-D1E61ACC522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rot="5400000">
              <a:off x="1977501" y="7277493"/>
              <a:ext cx="2610382" cy="2047854"/>
            </a:xfrm>
            <a:prstGeom prst="rect">
              <a:avLst/>
            </a:prstGeom>
          </p:spPr>
        </p:pic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55DBA55B-153D-D3EF-8DEB-04B30C8EFCDD}"/>
                </a:ext>
              </a:extLst>
            </p:cNvPr>
            <p:cNvSpPr txBox="1"/>
            <p:nvPr/>
          </p:nvSpPr>
          <p:spPr>
            <a:xfrm rot="5400000">
              <a:off x="-3009221" y="4761002"/>
              <a:ext cx="9448756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700" b="1" noProof="0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. 1 | Supercentenarian’s timeline, genealogical tree, and karyotype. a</a:t>
              </a:r>
              <a:r>
                <a:rPr lang="en-US" sz="7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, M116’s life timeline. </a:t>
              </a:r>
              <a:r>
                <a:rPr lang="en-US" sz="700" b="1" noProof="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7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, Genealogical tree of M116’s family showing age of death and causes of death, if known. Arrow points to M116. </a:t>
              </a:r>
              <a:r>
                <a:rPr lang="en-US" sz="700" b="1" noProof="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7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, G-banding karyotype of M116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190147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0585</TotalTime>
  <Words>58</Words>
  <Application>Microsoft Office PowerPoint</Application>
  <PresentationFormat>A4 (210 x 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loy Santos</dc:creator>
  <cp:lastModifiedBy>Eloy Santos</cp:lastModifiedBy>
  <cp:revision>331</cp:revision>
  <cp:lastPrinted>2024-12-23T09:31:56Z</cp:lastPrinted>
  <dcterms:created xsi:type="dcterms:W3CDTF">2024-03-13T15:19:51Z</dcterms:created>
  <dcterms:modified xsi:type="dcterms:W3CDTF">2025-02-19T11:10:09Z</dcterms:modified>
</cp:coreProperties>
</file>